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3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428596" y="6072206"/>
            <a:ext cx="8358246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20: </a:t>
            </a:r>
            <a:r>
              <a:rPr lang="en-GB" sz="1600" dirty="0" smtClean="0"/>
              <a:t>3D model structure and validation of</a:t>
            </a:r>
            <a:r>
              <a:rPr lang="en-US" sz="1600" dirty="0" smtClean="0"/>
              <a:t> FOS </a:t>
            </a:r>
            <a:r>
              <a:rPr lang="en-GB" sz="1600" dirty="0" smtClean="0"/>
              <a:t>gene. A) Wild (Template</a:t>
            </a:r>
            <a:r>
              <a:rPr lang="en-US" sz="1600" dirty="0" smtClean="0"/>
              <a:t> 2wt7_A)</a:t>
            </a:r>
            <a:r>
              <a:rPr lang="en-GB" sz="1600" dirty="0" smtClean="0"/>
              <a:t>, B) Mutant (Template</a:t>
            </a:r>
            <a:r>
              <a:rPr lang="en-US" sz="1600" dirty="0" smtClean="0"/>
              <a:t> 2wt7_A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714349" y="142852"/>
            <a:ext cx="2786081" cy="27968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357818" y="142852"/>
            <a:ext cx="2643206" cy="2928958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714348" y="3071810"/>
            <a:ext cx="2786082" cy="29079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357818" y="3214686"/>
            <a:ext cx="2643206" cy="2786082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64</cp:revision>
  <dcterms:created xsi:type="dcterms:W3CDTF">2018-05-10T07:33:24Z</dcterms:created>
  <dcterms:modified xsi:type="dcterms:W3CDTF">2018-05-29T07:00:34Z</dcterms:modified>
</cp:coreProperties>
</file>